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8" r:id="rId2"/>
    <p:sldId id="257" r:id="rId3"/>
    <p:sldId id="259" r:id="rId4"/>
    <p:sldId id="261" r:id="rId5"/>
    <p:sldId id="264" r:id="rId6"/>
    <p:sldId id="262" r:id="rId7"/>
    <p:sldId id="266" r:id="rId8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000"/>
    <a:srgbClr val="008000"/>
    <a:srgbClr val="B40000"/>
    <a:srgbClr val="008E00"/>
    <a:srgbClr val="0000FF"/>
    <a:srgbClr val="6C5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5110" autoAdjust="0"/>
  </p:normalViewPr>
  <p:slideViewPr>
    <p:cSldViewPr snapToGrid="0">
      <p:cViewPr>
        <p:scale>
          <a:sx n="70" d="100"/>
          <a:sy n="70" d="100"/>
        </p:scale>
        <p:origin x="330" y="9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59A9A0-9B80-493C-8522-E55A63608136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6B9266-C0EB-479E-A1D1-4DFA41168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2406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6B9266-C0EB-479E-A1D1-4DFA411687C7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32720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246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08376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idx="1" hasCustomPrompt="1"/>
          </p:nvPr>
        </p:nvSpPr>
        <p:spPr>
          <a:xfrm>
            <a:off x="672458" y="1126067"/>
            <a:ext cx="10554343" cy="4654020"/>
          </a:xfrm>
        </p:spPr>
        <p:txBody>
          <a:bodyPr/>
          <a:lstStyle>
            <a:lvl1pPr marL="285750" indent="-285750">
              <a:lnSpc>
                <a:spcPct val="100000"/>
              </a:lnSpc>
              <a:spcBef>
                <a:spcPts val="2000"/>
              </a:spcBef>
              <a:buClr>
                <a:schemeClr val="tx1">
                  <a:lumMod val="60000"/>
                  <a:lumOff val="40000"/>
                </a:schemeClr>
              </a:buClr>
              <a:buSzPct val="180000"/>
              <a:buFont typeface="Arial" pitchFamily="34" charset="0"/>
              <a:buChar char="ן"/>
              <a:defRPr sz="1800" baseline="0">
                <a:solidFill>
                  <a:schemeClr val="tx2"/>
                </a:solidFill>
              </a:defRPr>
            </a:lvl1pPr>
            <a:lvl2pPr marL="439738" marR="0" indent="-215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tx1"/>
              </a:buClr>
              <a:buSzTx/>
              <a:buFont typeface="Arial" pitchFamily="34" charset="0"/>
              <a:buChar char="•"/>
              <a:tabLst/>
              <a:defRPr b="0"/>
            </a:lvl2pPr>
            <a:lvl3pPr marL="360000" indent="-108000" algn="l" defTabSz="914400" rtl="0" eaLnBrk="1" latinLnBrk="0" hangingPunct="1">
              <a:spcBef>
                <a:spcPts val="300"/>
              </a:spcBef>
              <a:buClr>
                <a:schemeClr val="tx2"/>
              </a:buClr>
              <a:buSzPct val="100000"/>
              <a:buFont typeface="Arial" pitchFamily="34" charset="0"/>
              <a:buChar char="•"/>
              <a:defRPr lang="en-US" sz="1050" kern="1200" noProof="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</a:lstStyle>
          <a:p>
            <a:pPr lvl="0"/>
            <a:r>
              <a:rPr lang="en-US" noProof="0" dirty="0"/>
              <a:t>Click to add text</a:t>
            </a:r>
          </a:p>
          <a:p>
            <a:pPr lvl="1"/>
            <a:r>
              <a:rPr lang="en-US" noProof="0"/>
              <a:t>Second level</a:t>
            </a:r>
          </a:p>
          <a:p>
            <a:pPr lvl="1"/>
            <a:endParaRPr lang="en-US" noProof="0"/>
          </a:p>
        </p:txBody>
      </p:sp>
      <p:sp>
        <p:nvSpPr>
          <p:cNvPr id="4" name="Titre 3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</a:p>
        </p:txBody>
      </p:sp>
      <p:sp>
        <p:nvSpPr>
          <p:cNvPr id="13" name="Espace réservé pour une image  14"/>
          <p:cNvSpPr>
            <a:spLocks noGrp="1"/>
          </p:cNvSpPr>
          <p:nvPr>
            <p:ph type="pic" sz="quarter" idx="13" hasCustomPrompt="1"/>
          </p:nvPr>
        </p:nvSpPr>
        <p:spPr>
          <a:xfrm>
            <a:off x="9583060" y="6376706"/>
            <a:ext cx="2160000" cy="396000"/>
          </a:xfrm>
        </p:spPr>
        <p:txBody>
          <a:bodyPr anchor="ctr" anchorCtr="0">
            <a:noAutofit/>
          </a:bodyPr>
          <a:lstStyle>
            <a:lvl1pPr algn="ctr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noProof="0" dirty="0"/>
              <a:t>Co-branding logo</a:t>
            </a: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1"/>
            <a:ext cx="537197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800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551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14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4705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8853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9349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260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0392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283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816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F1AA05-1479-40B7-9E88-6186AE4B59AE}" type="datetimeFigureOut">
              <a:rPr lang="en-GB" smtClean="0"/>
              <a:t>14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7190-55DB-4EF2-8F92-338FD4717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364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Rectangle 99"/>
          <p:cNvSpPr/>
          <p:nvPr/>
        </p:nvSpPr>
        <p:spPr>
          <a:xfrm>
            <a:off x="6713359" y="3534106"/>
            <a:ext cx="5296671" cy="31700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0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2000" b="0" i="0" u="none" strike="noStrik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20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S gating strategy for quantifying immune cell subsets and FcγR expression in whole blood samples. All immune cells subsets are gated on A) live/single cells and histograms show relevant FcγR expression levels for B) Granulocytes (SSC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C) classical monocytes (FSC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D) non-classical monocytes (FSC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E) NK cells (SSC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m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F) B cells (SSC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 </a:t>
            </a:r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501219" y="746286"/>
            <a:ext cx="979170" cy="97917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1786275" y="746286"/>
            <a:ext cx="979170" cy="97917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>
            <a:grayscl/>
          </a:blip>
          <a:stretch>
            <a:fillRect/>
          </a:stretch>
        </p:blipFill>
        <p:spPr>
          <a:xfrm>
            <a:off x="3169961" y="732638"/>
            <a:ext cx="979170" cy="97917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>
            <a:grayscl/>
          </a:blip>
          <a:stretch>
            <a:fillRect/>
          </a:stretch>
        </p:blipFill>
        <p:spPr>
          <a:xfrm>
            <a:off x="503012" y="2347364"/>
            <a:ext cx="979170" cy="97917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86275" y="2336490"/>
            <a:ext cx="979170" cy="97917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15229" y="5564420"/>
            <a:ext cx="979170" cy="97917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8">
            <a:grayscl/>
          </a:blip>
          <a:stretch>
            <a:fillRect/>
          </a:stretch>
        </p:blipFill>
        <p:spPr>
          <a:xfrm>
            <a:off x="503954" y="3923147"/>
            <a:ext cx="979170" cy="97917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90327" y="3920028"/>
            <a:ext cx="979170" cy="97917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89928" y="3919724"/>
            <a:ext cx="979170" cy="97917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02812" y="3919724"/>
            <a:ext cx="979170" cy="97917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62591" y="3916697"/>
            <a:ext cx="979170" cy="97917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3">
            <a:grayscl/>
          </a:blip>
          <a:stretch>
            <a:fillRect/>
          </a:stretch>
        </p:blipFill>
        <p:spPr>
          <a:xfrm>
            <a:off x="487622" y="5550309"/>
            <a:ext cx="979170" cy="97917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710247" y="5541899"/>
            <a:ext cx="979170" cy="97917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5">
            <a:grayscl/>
          </a:blip>
          <a:stretch>
            <a:fillRect/>
          </a:stretch>
        </p:blipFill>
        <p:spPr>
          <a:xfrm>
            <a:off x="3719848" y="5578067"/>
            <a:ext cx="979170" cy="97917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867172" y="2335595"/>
            <a:ext cx="979170" cy="97917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547451" y="1626567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37315" y="1612919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20235" y="1602150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97648" y="4794774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14843" y="3234015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756268" y="3216398"/>
            <a:ext cx="1088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I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760583" y="3218254"/>
            <a:ext cx="12025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IIb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883462" y="4790011"/>
            <a:ext cx="8611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853458" y="4797717"/>
            <a:ext cx="1088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I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259305" y="4797700"/>
            <a:ext cx="10887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I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258494" y="4798375"/>
            <a:ext cx="1188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II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615078" y="6436303"/>
            <a:ext cx="1188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II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880087" y="6453771"/>
            <a:ext cx="11031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Ib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01657" y="6440345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881725" y="6455017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-74527" y="1065207"/>
            <a:ext cx="9268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-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-75492" y="2624126"/>
            <a:ext cx="9268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-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-77297" y="4200932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-32121" y="5852106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3204761" y="5862181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2595260" y="1034077"/>
            <a:ext cx="9268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-A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1193207" y="1063443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763916" y="918202"/>
            <a:ext cx="1505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nulocytes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580888" y="1217342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nocytes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465973" y="1397138"/>
            <a:ext cx="1492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Straight Arrow Connector 61"/>
          <p:cNvCxnSpPr/>
          <p:nvPr/>
        </p:nvCxnSpPr>
        <p:spPr>
          <a:xfrm flipV="1">
            <a:off x="939693" y="1104859"/>
            <a:ext cx="900000" cy="565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>
            <a:off x="2639452" y="1052910"/>
            <a:ext cx="612000" cy="3940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4310137" y="3590339"/>
            <a:ext cx="24032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sz="2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on-classical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845732" y="3590429"/>
            <a:ext cx="19143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sz="2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lassical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648398" y="5219076"/>
            <a:ext cx="11015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K cells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973151" y="5240380"/>
            <a:ext cx="8883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 cells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016739" y="1999042"/>
            <a:ext cx="16498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nulocytes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>
            <a:off x="938809" y="2768605"/>
            <a:ext cx="92102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>
            <a:off x="1334599" y="4640675"/>
            <a:ext cx="504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/>
          <p:cNvCxnSpPr/>
          <p:nvPr/>
        </p:nvCxnSpPr>
        <p:spPr>
          <a:xfrm>
            <a:off x="734170" y="5887048"/>
            <a:ext cx="1044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/>
          <p:nvPr/>
        </p:nvCxnSpPr>
        <p:spPr>
          <a:xfrm>
            <a:off x="3892665" y="5884618"/>
            <a:ext cx="10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Arc 98"/>
          <p:cNvSpPr/>
          <p:nvPr/>
        </p:nvSpPr>
        <p:spPr>
          <a:xfrm>
            <a:off x="-182224" y="4341114"/>
            <a:ext cx="5573634" cy="1868503"/>
          </a:xfrm>
          <a:prstGeom prst="arc">
            <a:avLst>
              <a:gd name="adj1" fmla="val 12177554"/>
              <a:gd name="adj2" fmla="val 2028148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93118" y="404106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28289" y="2002353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21068" y="3566227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896050" y="3576691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10833" y="5191004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349115" y="5218301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102621" y="94447"/>
            <a:ext cx="415668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2000" b="1" i="0" u="none" strike="noStrik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b="1" i="0" u="none" strike="noStrike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4591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916471"/>
              </p:ext>
            </p:extLst>
          </p:nvPr>
        </p:nvGraphicFramePr>
        <p:xfrm>
          <a:off x="0" y="568159"/>
          <a:ext cx="7996238" cy="5624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7" r:id="rId3" imgW="9587893" imgH="6743524" progId="Prism7.Document">
                  <p:embed/>
                </p:oleObj>
              </mc:Choice>
              <mc:Fallback>
                <p:oleObj name="Prism 7" r:id="rId3" imgW="9587893" imgH="674352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568159"/>
                        <a:ext cx="7996238" cy="5624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3860176" y="3167156"/>
            <a:ext cx="4683321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0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2000" b="0" i="0" u="none" strike="noStrik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b="0" i="0" u="none" strike="noStrike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000" b="0" i="0" u="none" strike="noStrik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20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s to mAb stimulation of PBMCs is stable over time. </a:t>
            </a:r>
            <a:r>
              <a:rPr lang="en-US" sz="2000" b="0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n-US" sz="2000" b="0" i="0" u="none" strike="noStrik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b="0" i="0" u="none" strike="noStrike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 healthy donors were stimulated with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OKT3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TGN1412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path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5 independent cytokine release assays carried out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 a period of 6 months. Each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int represents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from a single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ay.</a:t>
            </a:r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85619" y="168049"/>
            <a:ext cx="322026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8664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6902024" y="2474150"/>
            <a:ext cx="4268154" cy="40626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GB" sz="2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ease in response to mAb stimulation is significantly correlated with TNF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IL-1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L-6.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ase with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F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-1</a:t>
            </a:r>
            <a:r>
              <a:rPr lang="el-G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6 (log</a:t>
            </a:r>
            <a:r>
              <a:rPr lang="en-GB" sz="20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formed cytokine measurements) in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ze-thawed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MC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s stimulated with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-C) OKT3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-F) TGN1412 or (G-I) </a:t>
            </a:r>
            <a:r>
              <a:rPr lang="en-GB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path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ach point represents a donor, (n=36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ns = non-significant</a:t>
            </a:r>
            <a:endParaRPr lang="en-GB" sz="20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3924354"/>
              </p:ext>
            </p:extLst>
          </p:nvPr>
        </p:nvGraphicFramePr>
        <p:xfrm>
          <a:off x="3175" y="552450"/>
          <a:ext cx="7294563" cy="5800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5" name="Prism 8" r:id="rId3" imgW="9277096" imgH="7364070" progId="Prism8.Document">
                  <p:embed/>
                </p:oleObj>
              </mc:Choice>
              <mc:Fallback>
                <p:oleObj name="Prism 8" r:id="rId3" imgW="9277096" imgH="736407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75" y="552450"/>
                        <a:ext cx="7294563" cy="5800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122465" y="168769"/>
            <a:ext cx="284263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4594389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2722675"/>
              </p:ext>
            </p:extLst>
          </p:nvPr>
        </p:nvGraphicFramePr>
        <p:xfrm>
          <a:off x="0" y="114485"/>
          <a:ext cx="4918075" cy="6961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8" name="Prism 8" r:id="rId3" imgW="5046222" imgH="7144376" progId="Prism8.Document">
                  <p:embed/>
                </p:oleObj>
              </mc:Choice>
              <mc:Fallback>
                <p:oleObj name="Prism 8" r:id="rId3" imgW="5046222" imgH="714437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114485"/>
                        <a:ext cx="4918075" cy="6961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4415358" y="3486844"/>
            <a:ext cx="3876339" cy="34778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0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2000" b="0" i="0" u="none" strike="noStrik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b="0" i="0" u="none" strike="noStrike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20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cγR expression on pre- and post-high density culture of freeze-thawed PBMCs. FcγR expression was quantified on A-D) CD14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(monocytes), E) B cells and F) NK cells pre- and post-high density culture for 24 hours. Each point represents a donor (n=5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*p&lt;0.05, **p&lt;0.01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ns = non-significant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20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81885" y="-85570"/>
            <a:ext cx="284263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97330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1203150"/>
              </p:ext>
            </p:extLst>
          </p:nvPr>
        </p:nvGraphicFramePr>
        <p:xfrm>
          <a:off x="-117475" y="131763"/>
          <a:ext cx="5065713" cy="694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9" name="Prism 8" r:id="rId3" imgW="5331449" imgH="7301403" progId="Prism8.Document">
                  <p:embed/>
                </p:oleObj>
              </mc:Choice>
              <mc:Fallback>
                <p:oleObj name="Prism 8" r:id="rId3" imgW="5331449" imgH="730140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17475" y="131763"/>
                        <a:ext cx="5065713" cy="6943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4488531" y="2988960"/>
            <a:ext cx="4551816" cy="34778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GB" sz="20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 IFN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s to Campath and IgG1 Hexamer in a whole blood assay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mat.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ase in response to PBS (negative control), Campath and IgG1 Fc Hexamer using a whole blood assay format (n =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9).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p&lt;0.001, ns = non-significant. B) Correlation of IFN-</a:t>
            </a:r>
            <a:r>
              <a:rPr lang="el-G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ase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og</a:t>
            </a:r>
            <a:r>
              <a:rPr lang="en-GB" sz="20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formed) between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mpath and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1 Fc Hexamer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ponses.</a:t>
            </a:r>
          </a:p>
        </p:txBody>
      </p:sp>
      <p:sp>
        <p:nvSpPr>
          <p:cNvPr id="2" name="Rectangle 1"/>
          <p:cNvSpPr/>
          <p:nvPr/>
        </p:nvSpPr>
        <p:spPr>
          <a:xfrm>
            <a:off x="43929" y="-54592"/>
            <a:ext cx="2578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679999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189963" y="4727658"/>
            <a:ext cx="6359414" cy="604435"/>
          </a:xfrm>
        </p:spPr>
        <p:txBody>
          <a:bodyPr>
            <a:noAutofit/>
          </a:bodyPr>
          <a:lstStyle/>
          <a:p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itudinal study of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ase using a whole blood assay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mat. Whole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 was</a:t>
            </a:r>
            <a:r>
              <a:rPr lang="en-GB" sz="2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rced from 9 heathy donors on 5 separate days over a 4 month period and stimulated with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100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IgG1 Fc hexamer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B)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Campath. Data points represent individual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s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eraged from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plicate cultures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 3-5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points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donor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I and bars represent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IFN-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sponse for each donor.</a:t>
            </a:r>
            <a:r>
              <a:rPr lang="en-GB" sz="2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GB" sz="2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8607857"/>
              </p:ext>
            </p:extLst>
          </p:nvPr>
        </p:nvGraphicFramePr>
        <p:xfrm>
          <a:off x="0" y="438068"/>
          <a:ext cx="8570913" cy="337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4" name="Prism 7" r:id="rId3" imgW="9917417" imgH="3909112" progId="Prism7.Document">
                  <p:embed/>
                </p:oleObj>
              </mc:Choice>
              <mc:Fallback>
                <p:oleObj name="Prism 7" r:id="rId3" imgW="9917417" imgH="390911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438068"/>
                        <a:ext cx="8570913" cy="3375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189963" y="238013"/>
            <a:ext cx="284263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1906407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1945" y="-71193"/>
            <a:ext cx="4567050" cy="6929193"/>
            <a:chOff x="191945" y="-71193"/>
            <a:chExt cx="4567050" cy="6929193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68" t="6470" r="1511" b="18037"/>
            <a:stretch/>
          </p:blipFill>
          <p:spPr bwMode="auto">
            <a:xfrm>
              <a:off x="930664" y="508300"/>
              <a:ext cx="3636335" cy="23285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487483" y="377630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8411" y="927993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98679" y="145034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96271" y="199007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97778" y="251114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51204" y="274268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668910" y="2742683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540565" y="2742683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402183" y="2742683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261187" y="2742683"/>
              <a:ext cx="4942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314921" y="2984859"/>
              <a:ext cx="30190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donors per group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-205931" y="1465088"/>
              <a:ext cx="12513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wer (%)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69" t="6949" r="1391" b="18246"/>
            <a:stretch/>
          </p:blipFill>
          <p:spPr bwMode="auto">
            <a:xfrm>
              <a:off x="920306" y="3469107"/>
              <a:ext cx="3661861" cy="23072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854747" y="567018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672453" y="567018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544108" y="567018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405726" y="567018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264730" y="5670184"/>
              <a:ext cx="4942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318464" y="5869828"/>
              <a:ext cx="30190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donors per group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01658" y="332640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11953" y="3834237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12854" y="4335318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10446" y="4843149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01320" y="5342953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-197294" y="4374209"/>
              <a:ext cx="12513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wer (%)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1393279" y="6235737"/>
              <a:ext cx="2887533" cy="5902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1618640" y="6671227"/>
              <a:ext cx="237309" cy="0"/>
            </a:xfrm>
            <a:prstGeom prst="line">
              <a:avLst/>
            </a:prstGeom>
            <a:ln w="19050">
              <a:solidFill>
                <a:srgbClr val="6C52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2891551" y="6665252"/>
              <a:ext cx="237309" cy="0"/>
            </a:xfrm>
            <a:prstGeom prst="line">
              <a:avLst/>
            </a:prstGeom>
            <a:ln w="19050">
              <a:solidFill>
                <a:srgbClr val="B4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2283808" y="6674777"/>
              <a:ext cx="237309" cy="0"/>
            </a:xfrm>
            <a:prstGeom prst="line">
              <a:avLst/>
            </a:prstGeom>
            <a:ln w="19050">
              <a:solidFill>
                <a:srgbClr val="007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3425276" y="6668241"/>
              <a:ext cx="237309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1766230" y="6471061"/>
              <a:ext cx="473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454072" y="648866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054172" y="648866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581890" y="6471061"/>
              <a:ext cx="4479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325653" y="6188614"/>
              <a:ext cx="31172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d change between groups: 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193148" y="-71193"/>
              <a:ext cx="2842638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7</a:t>
              </a:r>
              <a:endParaRPr lang="en-GB" sz="2000" b="1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91945" y="260764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35056" y="3145574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7" name="Rectangle 56"/>
          <p:cNvSpPr/>
          <p:nvPr/>
        </p:nvSpPr>
        <p:spPr>
          <a:xfrm>
            <a:off x="4676328" y="445430"/>
            <a:ext cx="3876339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0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2000" b="0" i="0" u="none" strike="noStrik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b="0" i="0" u="none" strike="noStrike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20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wer</a:t>
            </a:r>
            <a:r>
              <a:rPr lang="en-GB" sz="2000" b="1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culation curves based on the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γ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sponse to A) </a:t>
            </a:r>
            <a:r>
              <a:rPr lang="en-GB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path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B) IgG1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xamer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imulation in whole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s.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4756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1</TotalTime>
  <Words>518</Words>
  <Application>Microsoft Office PowerPoint</Application>
  <PresentationFormat>Widescreen</PresentationFormat>
  <Paragraphs>84</Paragraphs>
  <Slides>7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Times New Roman</vt:lpstr>
      <vt:lpstr>Office Theme</vt:lpstr>
      <vt:lpstr>Prism 7</vt:lpstr>
      <vt:lpstr>Prism 8</vt:lpstr>
      <vt:lpstr>GraphPad Prism 8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 Supplementary Figure 6: Longitudinal study of IFN-γ release using a whole blood assay format. Whole blood was sourced from 9 heathy donors on 5 separate days over a 4 month period and stimulated with A) 100 g/mL IgG1 Fc hexamer or B) 10 g/mL Campath. Data points represent individual IFN- measurements averaged from triplicate cultures over 3-5 time points for each donor A-I and bars represent mean IFN- response for each donor.   </vt:lpstr>
      <vt:lpstr>PowerPoint Presentation</vt:lpstr>
    </vt:vector>
  </TitlesOfParts>
  <Company>no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sain K.</dc:creator>
  <cp:lastModifiedBy>Hussain K.</cp:lastModifiedBy>
  <cp:revision>36</cp:revision>
  <cp:lastPrinted>2019-01-04T10:30:20Z</cp:lastPrinted>
  <dcterms:created xsi:type="dcterms:W3CDTF">2018-10-24T17:18:33Z</dcterms:created>
  <dcterms:modified xsi:type="dcterms:W3CDTF">2019-01-14T11:10:17Z</dcterms:modified>
</cp:coreProperties>
</file>